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72" r:id="rId2"/>
    <p:sldId id="273" r:id="rId3"/>
    <p:sldId id="260" r:id="rId4"/>
    <p:sldId id="270" r:id="rId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FC9B138C-F08B-4A7D-A789-A15B7B192EAA}">
          <p14:sldIdLst>
            <p14:sldId id="272"/>
            <p14:sldId id="273"/>
            <p14:sldId id="260"/>
            <p14:sldId id="270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599"/>
    <p:restoredTop sz="94876"/>
  </p:normalViewPr>
  <p:slideViewPr>
    <p:cSldViewPr snapToGrid="0">
      <p:cViewPr varScale="1">
        <p:scale>
          <a:sx n="112" d="100"/>
          <a:sy n="112" d="100"/>
        </p:scale>
        <p:origin x="169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40DE-4436-4832-94EB-A26BC17E15F8}" type="datetimeFigureOut">
              <a:rPr lang="zh-CN" altLang="en-US" smtClean="0"/>
              <a:t>2020/10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684FD-2D78-4DBE-B2E5-5F005D0E23E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40DE-4436-4832-94EB-A26BC17E15F8}" type="datetimeFigureOut">
              <a:rPr lang="zh-CN" altLang="en-US" smtClean="0"/>
              <a:t>2020/10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684FD-2D78-4DBE-B2E5-5F005D0E23E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40DE-4436-4832-94EB-A26BC17E15F8}" type="datetimeFigureOut">
              <a:rPr lang="zh-CN" altLang="en-US" smtClean="0"/>
              <a:t>2020/10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684FD-2D78-4DBE-B2E5-5F005D0E23E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40DE-4436-4832-94EB-A26BC17E15F8}" type="datetimeFigureOut">
              <a:rPr lang="zh-CN" altLang="en-US" smtClean="0"/>
              <a:t>2020/10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684FD-2D78-4DBE-B2E5-5F005D0E23E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40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40DE-4436-4832-94EB-A26BC17E15F8}" type="datetimeFigureOut">
              <a:rPr lang="zh-CN" altLang="en-US" smtClean="0"/>
              <a:t>2020/10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684FD-2D78-4DBE-B2E5-5F005D0E23E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1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1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40DE-4436-4832-94EB-A26BC17E15F8}" type="datetimeFigureOut">
              <a:rPr lang="zh-CN" altLang="en-US" smtClean="0"/>
              <a:t>2020/10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684FD-2D78-4DBE-B2E5-5F005D0E23E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7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1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1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40DE-4436-4832-94EB-A26BC17E15F8}" type="datetimeFigureOut">
              <a:rPr lang="zh-CN" altLang="en-US" smtClean="0"/>
              <a:t>2020/10/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684FD-2D78-4DBE-B2E5-5F005D0E23E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40DE-4436-4832-94EB-A26BC17E15F8}" type="datetimeFigureOut">
              <a:rPr lang="zh-CN" altLang="en-US" smtClean="0"/>
              <a:t>2020/10/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684FD-2D78-4DBE-B2E5-5F005D0E23E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40DE-4436-4832-94EB-A26BC17E15F8}" type="datetimeFigureOut">
              <a:rPr lang="zh-CN" altLang="en-US" smtClean="0"/>
              <a:t>2020/10/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684FD-2D78-4DBE-B2E5-5F005D0E23E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7"/>
            <a:ext cx="462915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40DE-4436-4832-94EB-A26BC17E15F8}" type="datetimeFigureOut">
              <a:rPr lang="zh-CN" altLang="en-US" smtClean="0"/>
              <a:t>2020/10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684FD-2D78-4DBE-B2E5-5F005D0E23E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7"/>
            <a:ext cx="4629151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40DE-4436-4832-94EB-A26BC17E15F8}" type="datetimeFigureOut">
              <a:rPr lang="zh-CN" altLang="en-US" smtClean="0"/>
              <a:t>2020/10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684FD-2D78-4DBE-B2E5-5F005D0E23E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1" y="365127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1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BC40DE-4436-4832-94EB-A26BC17E15F8}" type="datetimeFigureOut">
              <a:rPr lang="zh-CN" altLang="en-US" smtClean="0"/>
              <a:t>2020/10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1" y="6356352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F684FD-2D78-4DBE-B2E5-5F005D0E23E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179705" y="713052"/>
            <a:ext cx="43982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Table S1. </a:t>
            </a:r>
            <a:r>
              <a:rPr lang="en-US" altLang="en-US" sz="1400" dirty="0"/>
              <a:t>Bacterial strains and plasmids used in this study</a:t>
            </a:r>
            <a:r>
              <a:rPr lang="en-US" sz="1400" dirty="0"/>
              <a:t> 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9705" y="1329690"/>
            <a:ext cx="8784590" cy="192786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40665" y="266217"/>
            <a:ext cx="37643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2000" b="1" dirty="0"/>
              <a:t>Table S2. </a:t>
            </a:r>
            <a:r>
              <a:rPr lang="en-US" altLang="en-US" sz="2000" dirty="0"/>
              <a:t>Primer </a:t>
            </a:r>
            <a:r>
              <a:rPr lang="en-US" altLang="en-US" sz="2000" dirty="0">
                <a:sym typeface="+mn-ea"/>
              </a:rPr>
              <a:t>used in this study</a:t>
            </a:r>
            <a:endParaRPr lang="en-US" altLang="en-US" sz="2000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0665" y="859284"/>
            <a:ext cx="8376285" cy="5207000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313732" y="411542"/>
            <a:ext cx="7043403" cy="30085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355" b="1" dirty="0"/>
              <a:t>Figure S1. </a:t>
            </a:r>
            <a:r>
              <a:rPr lang="en-US" altLang="zh-CN" sz="1355" dirty="0"/>
              <a:t>Variation detecting workflow by multiple calling tools and filter parameter for sublines. </a:t>
            </a:r>
            <a:endParaRPr lang="zh-CN" altLang="en-US" sz="1355" dirty="0"/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12394"/>
            <a:ext cx="8966200" cy="5842847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矩形 5"/>
          <p:cNvSpPr/>
          <p:nvPr/>
        </p:nvSpPr>
        <p:spPr>
          <a:xfrm>
            <a:off x="1322629" y="4717635"/>
            <a:ext cx="6630837" cy="50937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355" b="1" dirty="0"/>
              <a:t>Figure S2. </a:t>
            </a:r>
            <a:r>
              <a:rPr lang="en-US" altLang="zh-CN" sz="1355" dirty="0">
                <a:sym typeface="+mn-ea"/>
              </a:rPr>
              <a:t>Quantitative real time PCR analysis PAO1-A against PAO1-E (PAO1-E=1). Data represents mean± S.E.M of </a:t>
            </a:r>
            <a:r>
              <a:rPr lang="en-US" altLang="zh-CN" sz="1355" dirty="0">
                <a:solidFill>
                  <a:schemeClr val="tx1"/>
                </a:solidFill>
                <a:sym typeface="+mn-ea"/>
              </a:rPr>
              <a:t>3</a:t>
            </a:r>
            <a:r>
              <a:rPr lang="en-US" altLang="zh-CN" sz="1355" dirty="0">
                <a:solidFill>
                  <a:srgbClr val="FF0000"/>
                </a:solidFill>
                <a:sym typeface="+mn-ea"/>
              </a:rPr>
              <a:t> </a:t>
            </a:r>
            <a:r>
              <a:rPr lang="en-US" altLang="zh-CN" sz="1355" dirty="0">
                <a:sym typeface="+mn-ea"/>
              </a:rPr>
              <a:t>independent experiment(each experiment n = 2).</a:t>
            </a:r>
            <a:endParaRPr lang="en-US" altLang="zh-CN" sz="1355" dirty="0"/>
          </a:p>
        </p:txBody>
      </p:sp>
      <p:pic>
        <p:nvPicPr>
          <p:cNvPr id="2" name="Picture 1" descr="/Volumes/shared_drive/project_data/Project2/typing/diagram/20190928-qpcr.tiff20190928-qpcr"/>
          <p:cNvPicPr>
            <a:picLocks noChangeAspect="1"/>
          </p:cNvPicPr>
          <p:nvPr/>
        </p:nvPicPr>
        <p:blipFill>
          <a:blip r:embed="rId2"/>
          <a:srcRect/>
          <a:stretch>
            <a:fillRect/>
          </a:stretch>
        </p:blipFill>
        <p:spPr>
          <a:xfrm>
            <a:off x="2312035" y="503555"/>
            <a:ext cx="3839210" cy="3839210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33</TotalTime>
  <Words>71</Words>
  <Application>Microsoft Macintosh PowerPoint</Application>
  <PresentationFormat>On-screen Show (4:3)</PresentationFormat>
  <Paragraphs>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主题​​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un tu</dc:creator>
  <cp:lastModifiedBy>stephen ahator</cp:lastModifiedBy>
  <cp:revision>165</cp:revision>
  <dcterms:created xsi:type="dcterms:W3CDTF">2020-03-10T11:03:57Z</dcterms:created>
  <dcterms:modified xsi:type="dcterms:W3CDTF">2020-10-12T00:15:4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1033-11.1.0.8865</vt:lpwstr>
  </property>
</Properties>
</file>